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62" r:id="rId3"/>
    <p:sldId id="263" r:id="rId4"/>
    <p:sldId id="265" r:id="rId5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6FF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25" autoAdjust="0"/>
    <p:restoredTop sz="94660"/>
  </p:normalViewPr>
  <p:slideViewPr>
    <p:cSldViewPr snapToGrid="0">
      <p:cViewPr varScale="1">
        <p:scale>
          <a:sx n="86" d="100"/>
          <a:sy n="86" d="100"/>
        </p:scale>
        <p:origin x="466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fr-CH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fr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A94A2F-4D57-4CBA-B403-AAA638CDA4C0}" type="datetimeFigureOut">
              <a:rPr lang="fr-CH" smtClean="0"/>
              <a:t>06.06.2023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3E994-8008-431A-BFAE-E70440AC87AC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2864664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C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A94A2F-4D57-4CBA-B403-AAA638CDA4C0}" type="datetimeFigureOut">
              <a:rPr lang="fr-CH" smtClean="0"/>
              <a:t>06.06.2023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3E994-8008-431A-BFAE-E70440AC87AC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403302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fr-C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A94A2F-4D57-4CBA-B403-AAA638CDA4C0}" type="datetimeFigureOut">
              <a:rPr lang="fr-CH" smtClean="0"/>
              <a:t>06.06.2023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3E994-8008-431A-BFAE-E70440AC87AC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8617928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C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A94A2F-4D57-4CBA-B403-AAA638CDA4C0}" type="datetimeFigureOut">
              <a:rPr lang="fr-CH" smtClean="0"/>
              <a:t>06.06.2023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3E994-8008-431A-BFAE-E70440AC87AC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3489993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fr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A94A2F-4D57-4CBA-B403-AAA638CDA4C0}" type="datetimeFigureOut">
              <a:rPr lang="fr-CH" smtClean="0"/>
              <a:t>06.06.2023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3E994-8008-431A-BFAE-E70440AC87AC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487473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CH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CH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CH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A94A2F-4D57-4CBA-B403-AAA638CDA4C0}" type="datetimeFigureOut">
              <a:rPr lang="fr-CH" smtClean="0"/>
              <a:t>06.06.2023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3E994-8008-431A-BFAE-E70440AC87AC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9534111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fr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CH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CH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A94A2F-4D57-4CBA-B403-AAA638CDA4C0}" type="datetimeFigureOut">
              <a:rPr lang="fr-CH" smtClean="0"/>
              <a:t>06.06.2023</a:t>
            </a:fld>
            <a:endParaRPr lang="fr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3E994-8008-431A-BFAE-E70440AC87AC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6120823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CH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A94A2F-4D57-4CBA-B403-AAA638CDA4C0}" type="datetimeFigureOut">
              <a:rPr lang="fr-CH" smtClean="0"/>
              <a:t>06.06.2023</a:t>
            </a:fld>
            <a:endParaRPr lang="fr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3E994-8008-431A-BFAE-E70440AC87AC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8899071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A94A2F-4D57-4CBA-B403-AAA638CDA4C0}" type="datetimeFigureOut">
              <a:rPr lang="fr-CH" smtClean="0"/>
              <a:t>06.06.2023</a:t>
            </a:fld>
            <a:endParaRPr lang="fr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3E994-8008-431A-BFAE-E70440AC87AC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8664699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r-C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C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A94A2F-4D57-4CBA-B403-AAA638CDA4C0}" type="datetimeFigureOut">
              <a:rPr lang="fr-CH" smtClean="0"/>
              <a:t>06.06.2023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3E994-8008-431A-BFAE-E70440AC87AC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0827721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r-CH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C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A94A2F-4D57-4CBA-B403-AAA638CDA4C0}" type="datetimeFigureOut">
              <a:rPr lang="fr-CH" smtClean="0"/>
              <a:t>06.06.2023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3E994-8008-431A-BFAE-E70440AC87AC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0484363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fr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A94A2F-4D57-4CBA-B403-AAA638CDA4C0}" type="datetimeFigureOut">
              <a:rPr lang="fr-CH" smtClean="0"/>
              <a:t>06.06.2023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23E994-8008-431A-BFAE-E70440AC87AC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7593373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5.png"/><Relationship Id="rId4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4564" y="0"/>
            <a:ext cx="10162872" cy="6858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1149535" y="0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dirty="0"/>
              <a:t>Figure S1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603504" y="409694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b="1" dirty="0"/>
              <a:t>A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5981530" y="409694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b="1" dirty="0"/>
              <a:t>B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03504" y="3725394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b="1" dirty="0"/>
              <a:t>C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5981530" y="3725394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b="1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8889069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Picture 24"/>
          <p:cNvPicPr>
            <a:picLocks noChangeAspect="1"/>
          </p:cNvPicPr>
          <p:nvPr/>
        </p:nvPicPr>
        <p:blipFill rotWithShape="1">
          <a:blip r:embed="rId2"/>
          <a:srcRect t="6485" r="4064"/>
          <a:stretch/>
        </p:blipFill>
        <p:spPr>
          <a:xfrm>
            <a:off x="213906" y="3913152"/>
            <a:ext cx="5104329" cy="2829235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3"/>
          <a:srcRect l="506" t="12119" r="3097" b="1139"/>
          <a:stretch/>
        </p:blipFill>
        <p:spPr>
          <a:xfrm>
            <a:off x="5591503" y="620110"/>
            <a:ext cx="5412827" cy="2858814"/>
          </a:xfrm>
          <a:prstGeom prst="rect">
            <a:avLst/>
          </a:prstGeom>
        </p:spPr>
      </p:pic>
      <p:pic>
        <p:nvPicPr>
          <p:cNvPr id="24" name="Content Placeholder 3"/>
          <p:cNvPicPr>
            <a:picLocks noChangeAspect="1"/>
          </p:cNvPicPr>
          <p:nvPr/>
        </p:nvPicPr>
        <p:blipFill rotWithShape="1">
          <a:blip r:embed="rId4"/>
          <a:srcRect l="287" t="9491" r="1014" b="663"/>
          <a:stretch/>
        </p:blipFill>
        <p:spPr>
          <a:xfrm>
            <a:off x="231229" y="643058"/>
            <a:ext cx="5192109" cy="2834047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036048" y="334758"/>
            <a:ext cx="16941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600" dirty="0"/>
              <a:t>IDH mutant vs WT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088600" y="3650771"/>
            <a:ext cx="183563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600" dirty="0"/>
              <a:t>G-CIMP high vs </a:t>
            </a:r>
            <a:r>
              <a:rPr lang="fr-CH" sz="1600" dirty="0" err="1"/>
              <a:t>low</a:t>
            </a:r>
            <a:r>
              <a:rPr lang="fr-CH" sz="1600" dirty="0"/>
              <a:t> 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7525700" y="3706582"/>
            <a:ext cx="22580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FUBP1 </a:t>
            </a:r>
            <a:r>
              <a:rPr lang="en-GB" sz="1600" dirty="0" err="1"/>
              <a:t>LoF</a:t>
            </a:r>
            <a:r>
              <a:rPr lang="en-GB" sz="1600" dirty="0"/>
              <a:t> vs FUBP1 WT </a:t>
            </a:r>
            <a:endParaRPr lang="fr-CH" sz="1600" dirty="0"/>
          </a:p>
        </p:txBody>
      </p:sp>
      <p:sp>
        <p:nvSpPr>
          <p:cNvPr id="9" name="TextBox 8"/>
          <p:cNvSpPr txBox="1"/>
          <p:nvPr/>
        </p:nvSpPr>
        <p:spPr>
          <a:xfrm>
            <a:off x="10678252" y="0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dirty="0"/>
              <a:t>Figure S2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56035" y="36114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b="1" dirty="0"/>
              <a:t>A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5366389" y="218049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b="1" dirty="0"/>
              <a:t>B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0" y="3349225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b="1" dirty="0"/>
              <a:t>C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5310354" y="3349225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b="1" dirty="0"/>
              <a:t>D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t="49436" r="4017" b="28615"/>
          <a:stretch/>
        </p:blipFill>
        <p:spPr>
          <a:xfrm>
            <a:off x="5580993" y="4002949"/>
            <a:ext cx="5213131" cy="2855051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 rot="16200000">
            <a:off x="-441433" y="1660637"/>
            <a:ext cx="1295547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CH" sz="1100" dirty="0" err="1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fr-CH" sz="11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fr-CH" sz="1100" dirty="0" err="1">
                <a:latin typeface="Arial" panose="020B0604020202020204" pitchFamily="34" charset="0"/>
                <a:cs typeface="Arial" panose="020B0604020202020204" pitchFamily="34" charset="0"/>
              </a:rPr>
              <a:t>Genes</a:t>
            </a:r>
            <a:endParaRPr lang="fr-CH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8019394" y="3219425"/>
            <a:ext cx="1257075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CH" sz="1100" dirty="0" err="1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fr-CH" sz="1100" dirty="0">
                <a:latin typeface="Arial" panose="020B0604020202020204" pitchFamily="34" charset="0"/>
                <a:cs typeface="Arial" panose="020B0604020202020204" pitchFamily="34" charset="0"/>
              </a:rPr>
              <a:t> of exons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7951077" y="6543840"/>
            <a:ext cx="1257075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CH" sz="1100" dirty="0" err="1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fr-CH" sz="1100" dirty="0">
                <a:latin typeface="Arial" panose="020B0604020202020204" pitchFamily="34" charset="0"/>
                <a:cs typeface="Arial" panose="020B0604020202020204" pitchFamily="34" charset="0"/>
              </a:rPr>
              <a:t> of exons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2438400" y="6505904"/>
            <a:ext cx="1257075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CH" sz="1100" dirty="0" err="1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fr-CH" sz="1100" dirty="0">
                <a:latin typeface="Arial" panose="020B0604020202020204" pitchFamily="34" charset="0"/>
                <a:cs typeface="Arial" panose="020B0604020202020204" pitchFamily="34" charset="0"/>
              </a:rPr>
              <a:t> of exons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2275491" y="3084787"/>
            <a:ext cx="1371599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CH" sz="1100" dirty="0" err="1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fr-CH" sz="1100" dirty="0">
                <a:latin typeface="Arial" panose="020B0604020202020204" pitchFamily="34" charset="0"/>
                <a:cs typeface="Arial" panose="020B0604020202020204" pitchFamily="34" charset="0"/>
              </a:rPr>
              <a:t> of exons</a:t>
            </a:r>
          </a:p>
        </p:txBody>
      </p:sp>
      <p:sp>
        <p:nvSpPr>
          <p:cNvPr id="21" name="TextBox 20"/>
          <p:cNvSpPr txBox="1"/>
          <p:nvPr/>
        </p:nvSpPr>
        <p:spPr>
          <a:xfrm rot="16200000">
            <a:off x="5123796" y="5337260"/>
            <a:ext cx="1295547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CH" sz="1100" dirty="0" err="1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fr-CH" sz="11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fr-CH" sz="1100" dirty="0" err="1">
                <a:latin typeface="Arial" panose="020B0604020202020204" pitchFamily="34" charset="0"/>
                <a:cs typeface="Arial" panose="020B0604020202020204" pitchFamily="34" charset="0"/>
              </a:rPr>
              <a:t>Genes</a:t>
            </a:r>
            <a:endParaRPr lang="fr-CH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 rot="16200000">
            <a:off x="5029201" y="1910888"/>
            <a:ext cx="1295547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CH" sz="1100" dirty="0" err="1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fr-CH" sz="11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fr-CH" sz="1100" dirty="0" err="1">
                <a:latin typeface="Arial" panose="020B0604020202020204" pitchFamily="34" charset="0"/>
                <a:cs typeface="Arial" panose="020B0604020202020204" pitchFamily="34" charset="0"/>
              </a:rPr>
              <a:t>Genes</a:t>
            </a:r>
            <a:endParaRPr lang="fr-CH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 rot="16200000">
            <a:off x="-422373" y="5176352"/>
            <a:ext cx="1295547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CH" sz="1100" dirty="0" err="1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fr-CH" sz="11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fr-CH" sz="1100" dirty="0" err="1">
                <a:latin typeface="Arial" panose="020B0604020202020204" pitchFamily="34" charset="0"/>
                <a:cs typeface="Arial" panose="020B0604020202020204" pitchFamily="34" charset="0"/>
              </a:rPr>
              <a:t>Genes</a:t>
            </a:r>
            <a:endParaRPr lang="fr-CH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7662335" y="324248"/>
            <a:ext cx="176099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600" dirty="0" err="1"/>
              <a:t>Codel</a:t>
            </a:r>
            <a:r>
              <a:rPr lang="fr-CH" sz="1600" dirty="0"/>
              <a:t> vs non-</a:t>
            </a:r>
            <a:r>
              <a:rPr lang="fr-CH" sz="1600" dirty="0" err="1"/>
              <a:t>codel</a:t>
            </a:r>
            <a:endParaRPr lang="fr-CH" sz="1600" dirty="0"/>
          </a:p>
        </p:txBody>
      </p:sp>
    </p:spTree>
    <p:extLst>
      <p:ext uri="{BB962C8B-B14F-4D97-AF65-F5344CB8AC3E}">
        <p14:creationId xmlns:p14="http://schemas.microsoft.com/office/powerpoint/2010/main" val="170739136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2"/>
          <a:srcRect l="1166" t="12567" r="4012" b="1808"/>
          <a:stretch/>
        </p:blipFill>
        <p:spPr>
          <a:xfrm>
            <a:off x="199697" y="611323"/>
            <a:ext cx="5044966" cy="2625863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3"/>
          <a:srcRect l="1097" t="12060" r="4427" b="1856"/>
          <a:stretch/>
        </p:blipFill>
        <p:spPr>
          <a:xfrm>
            <a:off x="6127530" y="764824"/>
            <a:ext cx="4992415" cy="2566955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/>
          <a:srcRect t="12130" r="4580" b="-556"/>
          <a:stretch/>
        </p:blipFill>
        <p:spPr>
          <a:xfrm>
            <a:off x="210207" y="4049001"/>
            <a:ext cx="5023945" cy="2808999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951965" y="226392"/>
            <a:ext cx="16941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600" dirty="0"/>
              <a:t>IDH mutant vs WT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7841012" y="247414"/>
            <a:ext cx="176099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600" dirty="0" err="1"/>
              <a:t>Codel</a:t>
            </a:r>
            <a:r>
              <a:rPr lang="fr-CH" sz="1600" dirty="0"/>
              <a:t> vs non-</a:t>
            </a:r>
            <a:r>
              <a:rPr lang="fr-CH" sz="1600" dirty="0" err="1"/>
              <a:t>codel</a:t>
            </a:r>
            <a:endParaRPr lang="fr-CH" sz="1600" dirty="0"/>
          </a:p>
        </p:txBody>
      </p:sp>
      <p:sp>
        <p:nvSpPr>
          <p:cNvPr id="7" name="TextBox 6"/>
          <p:cNvSpPr txBox="1"/>
          <p:nvPr/>
        </p:nvSpPr>
        <p:spPr>
          <a:xfrm>
            <a:off x="1930946" y="3760223"/>
            <a:ext cx="183563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600" dirty="0"/>
              <a:t>G-CIMP high vs </a:t>
            </a:r>
            <a:r>
              <a:rPr lang="fr-CH" sz="1600" dirty="0" err="1"/>
              <a:t>low</a:t>
            </a:r>
            <a:r>
              <a:rPr lang="fr-CH" sz="1600" dirty="0"/>
              <a:t> 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7567743" y="3812775"/>
            <a:ext cx="22580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FUBP1 </a:t>
            </a:r>
            <a:r>
              <a:rPr lang="en-GB" sz="1600" dirty="0" err="1"/>
              <a:t>LoF</a:t>
            </a:r>
            <a:r>
              <a:rPr lang="en-GB" sz="1600" dirty="0"/>
              <a:t> vs FUBP1 WT </a:t>
            </a:r>
            <a:endParaRPr lang="fr-CH" sz="1600" dirty="0"/>
          </a:p>
        </p:txBody>
      </p:sp>
      <p:sp>
        <p:nvSpPr>
          <p:cNvPr id="9" name="TextBox 8"/>
          <p:cNvSpPr txBox="1"/>
          <p:nvPr/>
        </p:nvSpPr>
        <p:spPr>
          <a:xfrm>
            <a:off x="10678252" y="0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dirty="0"/>
              <a:t>Figure S3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0" y="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b="1" dirty="0"/>
              <a:t>A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5503015" y="0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b="1" dirty="0"/>
              <a:t>B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0" y="3356477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b="1" dirty="0"/>
              <a:t>C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5503015" y="3356477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b="1" dirty="0"/>
              <a:t>D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36" t="74659" r="4229" b="4532"/>
          <a:stretch/>
        </p:blipFill>
        <p:spPr>
          <a:xfrm>
            <a:off x="6086443" y="4113896"/>
            <a:ext cx="5180646" cy="2549821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7914288" y="6447193"/>
            <a:ext cx="2124299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CH" sz="1100" dirty="0" err="1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fr-CH" sz="11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fr-CH" sz="1100" dirty="0" err="1">
                <a:latin typeface="Arial" panose="020B0604020202020204" pitchFamily="34" charset="0"/>
                <a:cs typeface="Arial" panose="020B0604020202020204" pitchFamily="34" charset="0"/>
              </a:rPr>
              <a:t>transcripts</a:t>
            </a:r>
            <a:r>
              <a:rPr lang="fr-CH" sz="1100" dirty="0">
                <a:latin typeface="Arial" panose="020B0604020202020204" pitchFamily="34" charset="0"/>
                <a:cs typeface="Arial" panose="020B0604020202020204" pitchFamily="34" charset="0"/>
              </a:rPr>
              <a:t> per </a:t>
            </a:r>
            <a:r>
              <a:rPr lang="fr-CH" sz="1100" dirty="0" err="1">
                <a:latin typeface="Arial" panose="020B0604020202020204" pitchFamily="34" charset="0"/>
                <a:cs typeface="Arial" panose="020B0604020202020204" pitchFamily="34" charset="0"/>
              </a:rPr>
              <a:t>gene</a:t>
            </a:r>
            <a:endParaRPr lang="fr-CH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7898525" y="3168869"/>
            <a:ext cx="2124299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CH" sz="1100" dirty="0" err="1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fr-CH" sz="11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fr-CH" sz="1100" dirty="0" err="1">
                <a:latin typeface="Arial" panose="020B0604020202020204" pitchFamily="34" charset="0"/>
                <a:cs typeface="Arial" panose="020B0604020202020204" pitchFamily="34" charset="0"/>
              </a:rPr>
              <a:t>transcripts</a:t>
            </a:r>
            <a:r>
              <a:rPr lang="fr-CH" sz="1100" dirty="0">
                <a:latin typeface="Arial" panose="020B0604020202020204" pitchFamily="34" charset="0"/>
                <a:cs typeface="Arial" panose="020B0604020202020204" pitchFamily="34" charset="0"/>
              </a:rPr>
              <a:t> per </a:t>
            </a:r>
            <a:r>
              <a:rPr lang="fr-CH" sz="1100" dirty="0" err="1">
                <a:latin typeface="Arial" panose="020B0604020202020204" pitchFamily="34" charset="0"/>
                <a:cs typeface="Arial" panose="020B0604020202020204" pitchFamily="34" charset="0"/>
              </a:rPr>
              <a:t>gene</a:t>
            </a:r>
            <a:endParaRPr lang="fr-CH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986455" y="6520765"/>
            <a:ext cx="2238704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CH" sz="1100" dirty="0" err="1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fr-CH" sz="11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fr-CH" sz="1100" dirty="0" err="1">
                <a:latin typeface="Arial" panose="020B0604020202020204" pitchFamily="34" charset="0"/>
                <a:cs typeface="Arial" panose="020B0604020202020204" pitchFamily="34" charset="0"/>
              </a:rPr>
              <a:t>transcripts</a:t>
            </a:r>
            <a:r>
              <a:rPr lang="fr-CH" sz="1100" dirty="0">
                <a:latin typeface="Arial" panose="020B0604020202020204" pitchFamily="34" charset="0"/>
                <a:cs typeface="Arial" panose="020B0604020202020204" pitchFamily="34" charset="0"/>
              </a:rPr>
              <a:t> per </a:t>
            </a:r>
            <a:r>
              <a:rPr lang="fr-CH" sz="1100" dirty="0" err="1">
                <a:latin typeface="Arial" panose="020B0604020202020204" pitchFamily="34" charset="0"/>
                <a:cs typeface="Arial" panose="020B0604020202020204" pitchFamily="34" charset="0"/>
              </a:rPr>
              <a:t>gene</a:t>
            </a:r>
            <a:endParaRPr lang="fr-CH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844565" y="3063765"/>
            <a:ext cx="2124299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CH" sz="1100" dirty="0" err="1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fr-CH" sz="11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fr-CH" sz="1100" dirty="0" err="1">
                <a:latin typeface="Arial" panose="020B0604020202020204" pitchFamily="34" charset="0"/>
                <a:cs typeface="Arial" panose="020B0604020202020204" pitchFamily="34" charset="0"/>
              </a:rPr>
              <a:t>transcripts</a:t>
            </a:r>
            <a:r>
              <a:rPr lang="fr-CH" sz="1100" dirty="0">
                <a:latin typeface="Arial" panose="020B0604020202020204" pitchFamily="34" charset="0"/>
                <a:cs typeface="Arial" panose="020B0604020202020204" pitchFamily="34" charset="0"/>
              </a:rPr>
              <a:t> per </a:t>
            </a:r>
            <a:r>
              <a:rPr lang="fr-CH" sz="1100" dirty="0" err="1">
                <a:latin typeface="Arial" panose="020B0604020202020204" pitchFamily="34" charset="0"/>
                <a:cs typeface="Arial" panose="020B0604020202020204" pitchFamily="34" charset="0"/>
              </a:rPr>
              <a:t>gene</a:t>
            </a:r>
            <a:endParaRPr lang="fr-CH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 rot="16200000">
            <a:off x="-357349" y="5154427"/>
            <a:ext cx="1295547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CH" sz="1100" dirty="0" err="1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fr-CH" sz="11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fr-CH" sz="1100" dirty="0" err="1">
                <a:latin typeface="Arial" panose="020B0604020202020204" pitchFamily="34" charset="0"/>
                <a:cs typeface="Arial" panose="020B0604020202020204" pitchFamily="34" charset="0"/>
              </a:rPr>
              <a:t>Genes</a:t>
            </a:r>
            <a:endParaRPr lang="fr-CH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 rot="16200000">
            <a:off x="5533700" y="5254275"/>
            <a:ext cx="1295547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CH" sz="1100" dirty="0" err="1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fr-CH" sz="11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fr-CH" sz="1100" dirty="0" err="1">
                <a:latin typeface="Arial" panose="020B0604020202020204" pitchFamily="34" charset="0"/>
                <a:cs typeface="Arial" panose="020B0604020202020204" pitchFamily="34" charset="0"/>
              </a:rPr>
              <a:t>Genes</a:t>
            </a:r>
            <a:endParaRPr lang="fr-CH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 rot="16200000">
            <a:off x="5538955" y="1818296"/>
            <a:ext cx="1295547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CH" sz="1100" dirty="0" err="1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fr-CH" sz="11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fr-CH" sz="1100" dirty="0" err="1">
                <a:latin typeface="Arial" panose="020B0604020202020204" pitchFamily="34" charset="0"/>
                <a:cs typeface="Arial" panose="020B0604020202020204" pitchFamily="34" charset="0"/>
              </a:rPr>
              <a:t>Genes</a:t>
            </a:r>
            <a:endParaRPr lang="fr-CH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 rot="16200000">
            <a:off x="-436176" y="1665896"/>
            <a:ext cx="1295547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CH" sz="1100" dirty="0" err="1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fr-CH" sz="11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fr-CH" sz="1100" dirty="0" err="1">
                <a:latin typeface="Arial" panose="020B0604020202020204" pitchFamily="34" charset="0"/>
                <a:cs typeface="Arial" panose="020B0604020202020204" pitchFamily="34" charset="0"/>
              </a:rPr>
              <a:t>Genes</a:t>
            </a:r>
            <a:endParaRPr lang="fr-CH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5435808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1164336" y="2174022"/>
            <a:ext cx="9204960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ure S1</a:t>
            </a:r>
            <a:r>
              <a:rPr lang="en-US" sz="1200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Distribution of spliced genes on chromosomes for each indicated comparison. (A-D): Bar chart showing the number of differentially spliced genes (List, in red) compared to human genes as reference (Expected, in grey), on each chromosome. *** P value: significance (Chi-Squared test) is indicated on each graph. </a:t>
            </a:r>
          </a:p>
          <a:p>
            <a:endParaRPr lang="en-US" sz="1200" b="1" dirty="0"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US" sz="1200" b="1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ure S2</a:t>
            </a:r>
            <a:r>
              <a:rPr lang="en-US" sz="1200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Bar chart representing the number of exons (coding genes only) contained in differentially spliced genes (in red) compared to total coding genes (in grey), *** P value: significance (Chi-Squared test) is indicated on each graph. </a:t>
            </a:r>
          </a:p>
          <a:p>
            <a:endParaRPr lang="en-US" sz="1200" b="1" dirty="0"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US" sz="1200" b="1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ure S3</a:t>
            </a:r>
            <a:r>
              <a:rPr lang="en-US" sz="1200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Bar chart showing the number of transcript isoforms in the differentially spliced genes (in red) compared to coding genes (in grey), *** P value: significance (Chi-Squared test) is indicated on each graph. </a:t>
            </a:r>
            <a:endParaRPr lang="fr-CH" sz="1200" dirty="0"/>
          </a:p>
        </p:txBody>
      </p:sp>
      <p:sp>
        <p:nvSpPr>
          <p:cNvPr id="9" name="TextBox 8"/>
          <p:cNvSpPr txBox="1"/>
          <p:nvPr/>
        </p:nvSpPr>
        <p:spPr>
          <a:xfrm>
            <a:off x="1164336" y="1335024"/>
            <a:ext cx="47598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dirty="0"/>
              <a:t>Legends to </a:t>
            </a:r>
            <a:r>
              <a:rPr lang="fr-CH" dirty="0" err="1"/>
              <a:t>Supplementary</a:t>
            </a:r>
            <a:r>
              <a:rPr lang="fr-CH" dirty="0"/>
              <a:t> Figures S1, S2 and S3.</a:t>
            </a:r>
          </a:p>
        </p:txBody>
      </p:sp>
    </p:spTree>
    <p:extLst>
      <p:ext uri="{BB962C8B-B14F-4D97-AF65-F5344CB8AC3E}">
        <p14:creationId xmlns:p14="http://schemas.microsoft.com/office/powerpoint/2010/main" val="12793727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835</TotalTime>
  <Words>273</Words>
  <Application>Microsoft Office PowerPoint</Application>
  <PresentationFormat>Widescreen</PresentationFormat>
  <Paragraphs>45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Palatino Linotype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Luxembourg Institute of Healt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ric Van Dyck</dc:creator>
  <cp:lastModifiedBy>MDPI</cp:lastModifiedBy>
  <cp:revision>43</cp:revision>
  <dcterms:created xsi:type="dcterms:W3CDTF">2022-10-26T10:57:30Z</dcterms:created>
  <dcterms:modified xsi:type="dcterms:W3CDTF">2023-06-06T13:24:14Z</dcterms:modified>
</cp:coreProperties>
</file>